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9" r:id="rId2"/>
    <p:sldId id="267" r:id="rId3"/>
    <p:sldId id="26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378" autoAdjust="0"/>
  </p:normalViewPr>
  <p:slideViewPr>
    <p:cSldViewPr>
      <p:cViewPr>
        <p:scale>
          <a:sx n="100" d="100"/>
          <a:sy n="100" d="100"/>
        </p:scale>
        <p:origin x="-1980" y="-3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970233-723E-49A9-A273-74829ADB7931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09CF5-D9B8-4E59-9D78-27AC8DBD3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5224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C09CF5-D9B8-4E59-9D78-27AC8DBD3A0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7065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C09CF5-D9B8-4E59-9D78-27AC8DBD3A0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8320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C09CF5-D9B8-4E59-9D78-27AC8DBD3A0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706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22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439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24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482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817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138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914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236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68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046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805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D7104-ACDB-4766-9024-3854271FA40B}" type="datetimeFigureOut">
              <a:rPr lang="en-US" smtClean="0"/>
              <a:t>3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C9F95D-5EA0-49CF-847A-3A5274C6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56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3151" y="35332"/>
            <a:ext cx="2864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S1, </a:t>
            </a:r>
            <a:r>
              <a:rPr lang="da-DK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 file 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90380"/>
              </p:ext>
            </p:extLst>
          </p:nvPr>
        </p:nvGraphicFramePr>
        <p:xfrm>
          <a:off x="1524000" y="1397000"/>
          <a:ext cx="6216350" cy="2932157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1175792"/>
                <a:gridCol w="1224136"/>
                <a:gridCol w="1329882"/>
                <a:gridCol w="1243270"/>
                <a:gridCol w="1243270"/>
              </a:tblGrid>
              <a:tr h="920477">
                <a:tc>
                  <a:txBody>
                    <a:bodyPr/>
                    <a:lstStyle/>
                    <a:p>
                      <a:pPr algn="ctr"/>
                      <a:r>
                        <a:rPr lang="da-DK" b="0" dirty="0" err="1" smtClean="0">
                          <a:solidFill>
                            <a:schemeClr val="tx1"/>
                          </a:solidFill>
                        </a:rPr>
                        <a:t>Figure</a:t>
                      </a:r>
                      <a:r>
                        <a:rPr lang="da-DK" b="0" dirty="0" smtClean="0">
                          <a:solidFill>
                            <a:schemeClr val="tx1"/>
                          </a:solidFill>
                        </a:rPr>
                        <a:t> 1A</a:t>
                      </a:r>
                      <a:endParaRPr lang="da-DK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b="0" dirty="0" err="1" smtClean="0">
                          <a:solidFill>
                            <a:schemeClr val="tx1"/>
                          </a:solidFill>
                        </a:rPr>
                        <a:t>Figure</a:t>
                      </a:r>
                      <a:r>
                        <a:rPr lang="da-DK" b="0" dirty="0" smtClean="0">
                          <a:solidFill>
                            <a:schemeClr val="tx1"/>
                          </a:solidFill>
                        </a:rPr>
                        <a:t> 1B</a:t>
                      </a:r>
                      <a:endParaRPr lang="da-DK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b="0" dirty="0" err="1" smtClean="0">
                          <a:solidFill>
                            <a:schemeClr val="tx1"/>
                          </a:solidFill>
                        </a:rPr>
                        <a:t>Figure</a:t>
                      </a:r>
                      <a:r>
                        <a:rPr lang="da-DK" b="0" dirty="0" smtClean="0">
                          <a:solidFill>
                            <a:schemeClr val="tx1"/>
                          </a:solidFill>
                        </a:rPr>
                        <a:t> 1C</a:t>
                      </a:r>
                      <a:endParaRPr lang="da-DK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b="0" dirty="0" err="1" smtClean="0">
                          <a:solidFill>
                            <a:schemeClr val="tx1"/>
                          </a:solidFill>
                        </a:rPr>
                        <a:t>Figure</a:t>
                      </a:r>
                      <a:r>
                        <a:rPr lang="da-DK" b="0" dirty="0" smtClean="0">
                          <a:solidFill>
                            <a:schemeClr val="tx1"/>
                          </a:solidFill>
                        </a:rPr>
                        <a:t> 2A</a:t>
                      </a:r>
                      <a:endParaRPr lang="da-DK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b="0" dirty="0" err="1" smtClean="0">
                          <a:solidFill>
                            <a:schemeClr val="tx1"/>
                          </a:solidFill>
                        </a:rPr>
                        <a:t>Figure</a:t>
                      </a:r>
                      <a:r>
                        <a:rPr lang="da-DK" b="0" dirty="0" smtClean="0">
                          <a:solidFill>
                            <a:schemeClr val="tx1"/>
                          </a:solidFill>
                        </a:rPr>
                        <a:t> 2B</a:t>
                      </a:r>
                      <a:endParaRPr lang="da-DK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533292">
                <a:tc>
                  <a:txBody>
                    <a:bodyPr/>
                    <a:lstStyle/>
                    <a:p>
                      <a:pPr algn="ctr"/>
                      <a:r>
                        <a:rPr lang="da-DK" dirty="0" smtClean="0"/>
                        <a:t>K562</a:t>
                      </a:r>
                      <a:endParaRPr lang="da-DK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sv-SE" dirty="0" smtClean="0"/>
                        <a:t> Gm12878</a:t>
                      </a:r>
                    </a:p>
                    <a:p>
                      <a:pPr algn="ctr"/>
                      <a:r>
                        <a:rPr lang="sv-SE" dirty="0" smtClean="0"/>
                        <a:t>HeLa-S3</a:t>
                      </a:r>
                    </a:p>
                    <a:p>
                      <a:pPr algn="ctr"/>
                      <a:r>
                        <a:rPr lang="sv-SE" dirty="0" smtClean="0"/>
                        <a:t>HepG2</a:t>
                      </a:r>
                    </a:p>
                    <a:p>
                      <a:pPr algn="ctr"/>
                      <a:r>
                        <a:rPr lang="sv-SE" dirty="0" smtClean="0"/>
                        <a:t>K562</a:t>
                      </a:r>
                    </a:p>
                    <a:p>
                      <a:pPr algn="ctr"/>
                      <a:r>
                        <a:rPr lang="sv-SE" dirty="0" smtClean="0"/>
                        <a:t>MCF7</a:t>
                      </a:r>
                      <a:endParaRPr lang="da-DK" baseline="0" dirty="0" smtClean="0"/>
                    </a:p>
                    <a:p>
                      <a:pPr algn="ctr"/>
                      <a:endParaRPr lang="da-DK" baseline="0" dirty="0" smtClean="0"/>
                    </a:p>
                    <a:p>
                      <a:pPr algn="ctr"/>
                      <a:endParaRPr lang="da-DK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dirty="0" smtClean="0"/>
                        <a:t>Gm12878</a:t>
                      </a:r>
                    </a:p>
                    <a:p>
                      <a:pPr algn="ctr"/>
                      <a:r>
                        <a:rPr lang="da-DK" dirty="0" smtClean="0"/>
                        <a:t>HeLa-S3</a:t>
                      </a:r>
                    </a:p>
                    <a:p>
                      <a:pPr algn="ctr"/>
                      <a:r>
                        <a:rPr lang="da-DK" dirty="0" smtClean="0"/>
                        <a:t>HepG2</a:t>
                      </a:r>
                    </a:p>
                    <a:p>
                      <a:pPr algn="ctr"/>
                      <a:r>
                        <a:rPr lang="da-DK" dirty="0" smtClean="0"/>
                        <a:t>K5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dirty="0" smtClean="0"/>
                        <a:t>K562</a:t>
                      </a:r>
                    </a:p>
                    <a:p>
                      <a:pPr algn="ctr"/>
                      <a:r>
                        <a:rPr lang="da-DK" dirty="0" smtClean="0"/>
                        <a:t>MCF7</a:t>
                      </a:r>
                      <a:endParaRPr lang="da-DK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dirty="0" smtClean="0"/>
                        <a:t>H1</a:t>
                      </a:r>
                      <a:r>
                        <a:rPr lang="da-DK" baseline="0" dirty="0" smtClean="0"/>
                        <a:t> </a:t>
                      </a:r>
                      <a:r>
                        <a:rPr lang="da-DK" dirty="0" err="1" smtClean="0"/>
                        <a:t>hESC</a:t>
                      </a:r>
                      <a:endParaRPr lang="da-DK" dirty="0" smtClean="0"/>
                    </a:p>
                    <a:p>
                      <a:pPr algn="ctr"/>
                      <a:r>
                        <a:rPr lang="da-DK" dirty="0" smtClean="0"/>
                        <a:t>K562</a:t>
                      </a:r>
                      <a:endParaRPr lang="da-DK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82794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3151" y="35332"/>
            <a:ext cx="2864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S2, </a:t>
            </a:r>
            <a:r>
              <a:rPr lang="da-DK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 file 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52000" y="414366"/>
            <a:ext cx="8640000" cy="60292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44532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3151" y="35332"/>
            <a:ext cx="2864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S3, </a:t>
            </a:r>
            <a:r>
              <a:rPr lang="da-DK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da-DK" dirty="0" smtClean="0">
                <a:latin typeface="Arial" panose="020B0604020202020204" pitchFamily="34" charset="0"/>
                <a:cs typeface="Arial" panose="020B0604020202020204" pitchFamily="34" charset="0"/>
              </a:rPr>
              <a:t> file 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150" y="962025"/>
            <a:ext cx="8267700" cy="4933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41382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63</TotalTime>
  <Words>47</Words>
  <Application>Microsoft Office PowerPoint</Application>
  <PresentationFormat>On-screen Show (4:3)</PresentationFormat>
  <Paragraphs>25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</dc:creator>
  <cp:lastModifiedBy>Martin</cp:lastModifiedBy>
  <cp:revision>89</cp:revision>
  <dcterms:created xsi:type="dcterms:W3CDTF">2013-09-10T20:36:27Z</dcterms:created>
  <dcterms:modified xsi:type="dcterms:W3CDTF">2015-03-06T12:32:36Z</dcterms:modified>
</cp:coreProperties>
</file>